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58" y="530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126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3912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5936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439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4838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7634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0394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8770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1785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720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9520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7EF43-BF9C-4ABB-B6AE-91BA99C61F7F}" type="datetimeFigureOut">
              <a:rPr lang="fr-FR" smtClean="0"/>
              <a:t>31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D38E13-1C32-4050-9352-6DB072F6A4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8948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0648" y="68872"/>
            <a:ext cx="6264696" cy="89255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ocument S1: Amino-acid sequences and multiple sequence </a:t>
            </a:r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ignement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three </a:t>
            </a:r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eologous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at proteins considered as potential </a:t>
            </a:r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s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en-US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achyon</a:t>
            </a:r>
            <a:r>
              <a:rPr lang="en-US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di5g03300 UGT.</a:t>
            </a:r>
            <a:endParaRPr lang="fr-F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Traes_2AS_99FF5C043.1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ELTWRAITVGPTLPSFYLDDDRLPSNKSYGFNLFGSDAPCMDWLEKQSISSVVLVSYGTFSNYDATQLDELGNGLCNCGKSFLWVVRSNEAHKLSEELRKSCEKNGLIVSWCPQLEVLAHKAIGCFVTHCGWNSTLEAVVCGIPLVGIPHWADQPTIAKYVESAWGMGVRVQKSESGSLRSAEVERCIRDVMDGERKDDYKRNAMKWMQKAKEAMQEGGSSDKHIAEFAAKYFQQCNLYFKISK*</a:t>
            </a:r>
          </a:p>
          <a:p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Traes_2BS_14CA35D5D.1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ESTGHGGGEGASVLLLPFPGAQGHTNPLLELGRRLARHGLHPTLVATRHVLSSTPPPGAPFRVAAISDGFDAGGAASDYTEYFSRLEAVGSETLRELLLSEARAGRPVRVLVYDSHLPWAGRVARAAGVPAAAFFSQPCSVNIVYGELWAGRLALPVMDGAGPELLARGALGVELGPEDVPPFAAAPESQPSFLKMAIGQFDGLEDTDDVLVNSFNDIEPTEGEFMELTWRKKTIGPTLPSFYLDDHRLPSNKSYGFNLFDSDAPCMDWLENQSISSVVLVSYGTFSNYDATQLEELGNGICNSGKSFLWVVRSNEAHKLSEELRKKCEKNGLIVSWCPQLEVLAHKAIGCFVTHCGWNSTLEAVVCGVPLVGIPHWADQPTIAKYVESGWGMGVRVQKSESESLRSAEVERCIREVMDGERKGEYKRNAIKWMQKAKEAMQEGGSSDKHIAEFAAKYSSI*</a:t>
            </a:r>
          </a:p>
          <a:p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Traes_2DS_5CE0A969D.1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SIGQFDGLEEADDVLVNSFSDIEPTEAEYMELTWGAKTVGPTLPSFYLEDDRLPSNKSYGFNLFGDDAPCLDWLQEQSISSVVLVSYGTFSNYDATQLEELGNGVCSSGKPFLWVVRSNEAHKLSEEVKAKCEKNGLIVSWCPQLEVLAHKAIGCFVTHCGWNSTLEAVVCGVPLVGIPHWADQHTIAKYVESAWDIGVRARKSENGLLRSGEVGRCIREVMDGERKDEYKRNATKLMQKAKEAMRDGGSSDKHIAEFAAKYSSI*</a:t>
            </a:r>
          </a:p>
          <a:p>
            <a:endParaRPr lang="fr-FR" sz="8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--------------------------------------------------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MESTGHGGGEGASVLLLPFPGAQGHTNPLLELGRRLARHGLHPTLVATRH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VLSSTPPPGAPFRVAAISDGFDAGGAASDYTEYFSRLEAVGSETLRELLL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SEARAGRPVRVLVYDSHLPWAGRVARAAGVPAAAFFSQPCSVNIVYGELW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-----------------------------------------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AGRLALPVMDGAGPELLARGALGVELGPEDVPPFAAAPESQPSFLKMAIG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----------------------------------------------MSIG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--------------------------MELTWRAITVGPTLPSFYLDDDRL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QFDGLEDTDDVLVNSFNDIEPTEGEFMELTWRKKTIGPTLPSFYLDDHRL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QFDGLEEADDVLVNSFSDIEPTEAEYMELTWGAKTVGPTLPSFYLEDDRL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*****   *:*********:*.**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PSNKSYGFNLFGSDAPCMDWLEKQSISSVVLVSYGTFSNYDATQLDELGN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PSNKSYGFNLFDSDAPCMDWLENQSISSVVLVSYGTFSNYDATQLEELGN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PSNKSYGFNLFGDDAPCLDWLQEQSISSVVLVSYGTFSNYDATQLEELGN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***********..****:***::**********************:****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GLCNCGKSFLWVVRSNEAHKLSEELRKSCEKNGLIVSWCPQLEVLAHKAI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GICNSGKSFLWVVRSNEAHKLSEELRKKCEKNGLIVSWCPQLEVLAHKAI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GVCSSGKPFLWVVRSNEAHKLSEEVKAKCEKNGLIVSWCPQLEVLAHKAI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*:*..**.****************:: .**********************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GCFVTHCGWNSTLEAVVCGIPLVGIPHWADQPTIAKYVESAWGMGVRVQ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GCFVTHCGWNSTLEAVVCGVPLVGIPHWADQPTIAKYVESGWGMGVRVQ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GCFVTHCGWNSTLEAVVCGVPLVGIPHWADQHTIAKYVESAWDIGVRAR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*******************:*********** ********.*.:***.:*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SESGSLRSAEVERCIRDVMDGERKDDYKRNAMKWMQKAKEAMQEGGSSD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SESESLRSAEVERCIREVMDGERKGEYKRNAIKWMQKAKEAMQEGGSSD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SENGLLRSGEVGRCIREVMDGERKDEYKRNATKLMQKAKEAMRDGGSSD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**.  ***.** ****:*******.:***** * ********::******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AS_99FF5C043.1      HIAEFAAKYFQQCNLYFKISK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BS_14CA35D5D.1      HIAEFAAKYSSI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raes_2DS_5CE0A969D.1      HIAEFAAKYSSI---------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********* .      </a:t>
            </a:r>
          </a:p>
          <a:p>
            <a:r>
              <a:rPr lang="fr-FR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37636681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Office PowerPoint</Application>
  <PresentationFormat>Affichage à l'écran (4:3)</PresentationFormat>
  <Paragraphs>6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PS2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 Dufresne</dc:creator>
  <cp:lastModifiedBy>Marie Dufresne</cp:lastModifiedBy>
  <cp:revision>1</cp:revision>
  <dcterms:created xsi:type="dcterms:W3CDTF">2018-05-31T11:53:23Z</dcterms:created>
  <dcterms:modified xsi:type="dcterms:W3CDTF">2018-05-31T11:56:52Z</dcterms:modified>
</cp:coreProperties>
</file>